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88" r:id="rId2"/>
    <p:sldId id="289" r:id="rId3"/>
  </p:sldIdLst>
  <p:sldSz cx="7559675" cy="1069181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413" userDrawn="1">
          <p15:clr>
            <a:srgbClr val="A4A3A4"/>
          </p15:clr>
        </p15:guide>
        <p15:guide id="2" pos="22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977" autoAdjust="0"/>
    <p:restoredTop sz="94660"/>
  </p:normalViewPr>
  <p:slideViewPr>
    <p:cSldViewPr snapToGrid="0">
      <p:cViewPr>
        <p:scale>
          <a:sx n="47" d="100"/>
          <a:sy n="47" d="100"/>
        </p:scale>
        <p:origin x="-1410" y="-24"/>
      </p:cViewPr>
      <p:guideLst>
        <p:guide orient="horz" pos="3413"/>
        <p:guide pos="22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gendary\AppData\Local\Microsoft\Windows\Temporary%20Internet%20Files\Content.Outlook\BHI85M6I\RNA%20seq%20validation_Down%20&#52572;&#51333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gendary\AppData\Local\Microsoft\Windows\Temporary%20Internet%20Files\Content.Outlook\BHI85M6I\RNA%20seq%20validation_Down%20&#52572;&#51333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gendary\AppData\Local\Microsoft\Windows\Temporary%20Internet%20Files\Content.Outlook\BHI85M6I\RNA%20seq%20validation_Down%20&#52572;&#51333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gendary\AppData\Local\Microsoft\Windows\Temporary%20Internet%20Files\Content.Outlook\BHI85M6I\RNA%20seq%20validation_Down%20&#52572;&#51333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gendary\AppData\Local\Microsoft\Windows\Temporary%20Internet%20Files\Content.Outlook\BHI85M6I\RNA%20seq%20validation_Down%20&#52572;&#51333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gendary\AppData\Local\Microsoft\Windows\Temporary%20Internet%20Files\Content.Outlook\BHI85M6I\RNA%20seq%20validation_Down%20&#52572;&#51333;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&#53685;&#54633;%20&#47928;&#49436;2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&#53685;&#54633;%20&#47928;&#49436;2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&#53685;&#54633;%20&#47928;&#49436;2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i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ko-KR" sz="900" i="0" dirty="0" smtClean="0">
                <a:latin typeface="Arial" panose="020B0604020202020204" pitchFamily="34" charset="0"/>
                <a:cs typeface="Arial" panose="020B0604020202020204" pitchFamily="34" charset="0"/>
              </a:rPr>
              <a:t>LOC_Os12g03040</a:t>
            </a:r>
            <a:endParaRPr lang="en-US" altLang="ko-KR" sz="900" i="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52237427288517"/>
          <c:y val="2.421089033563811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6556726183874901"/>
          <c:y val="0.1701753837061758"/>
          <c:w val="0.61236701046172048"/>
          <c:h val="0.708676018146738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NA seq validation_Down 최종.xlsx]Down_Vil2 만'!$J$48</c:f>
              <c:strCache>
                <c:ptCount val="1"/>
                <c:pt idx="0">
                  <c:v>12g03040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D95-4C16-89AC-83F02E4335AA}"/>
              </c:ext>
            </c:extLst>
          </c:dPt>
          <c:errBars>
            <c:errBarType val="both"/>
            <c:errValType val="cust"/>
            <c:noEndCap val="0"/>
            <c:plus>
              <c:numRef>
                <c:f>'[RNA seq validation_Down 최종.xlsx]Down_Vil2 만'!$K$49:$K$50</c:f>
                <c:numCache>
                  <c:formatCode>General</c:formatCode>
                  <c:ptCount val="2"/>
                  <c:pt idx="0">
                    <c:v>1.0921202332715737E-3</c:v>
                  </c:pt>
                  <c:pt idx="1">
                    <c:v>4.9906744806389069E-5</c:v>
                  </c:pt>
                </c:numCache>
              </c:numRef>
            </c:plus>
            <c:minus>
              <c:numRef>
                <c:f>'[RNA seq validation_Down 최종.xlsx]Down_Vil2 만'!$K$49:$K$50</c:f>
                <c:numCache>
                  <c:formatCode>General</c:formatCode>
                  <c:ptCount val="2"/>
                  <c:pt idx="0">
                    <c:v>1.0921202332715737E-3</c:v>
                  </c:pt>
                  <c:pt idx="1">
                    <c:v>4.9906744806389069E-5</c:v>
                  </c:pt>
                </c:numCache>
              </c:numRef>
            </c:minus>
          </c:errBars>
          <c:cat>
            <c:strRef>
              <c:f>'[RNA seq validation_Down 최종.xlsx]Down_Vil2 만'!$I$49:$I$50</c:f>
              <c:strCache>
                <c:ptCount val="2"/>
                <c:pt idx="0">
                  <c:v>WT</c:v>
                </c:pt>
                <c:pt idx="1">
                  <c:v>OsVIL2 OX</c:v>
                </c:pt>
              </c:strCache>
            </c:strRef>
          </c:cat>
          <c:val>
            <c:numRef>
              <c:f>'[RNA seq validation_Down 최종.xlsx]Down_Vil2 만'!$J$49:$J$50</c:f>
              <c:numCache>
                <c:formatCode>General</c:formatCode>
                <c:ptCount val="2"/>
                <c:pt idx="0">
                  <c:v>1.1744471214520467E-2</c:v>
                </c:pt>
                <c:pt idx="1">
                  <c:v>1.018644427031809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D95-4C16-89AC-83F02E4335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512000"/>
        <c:axId val="83383360"/>
      </c:barChart>
      <c:catAx>
        <c:axId val="40512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700"/>
            </a:pPr>
            <a:endParaRPr lang="ko-KR"/>
          </a:p>
        </c:txPr>
        <c:crossAx val="83383360"/>
        <c:crosses val="autoZero"/>
        <c:auto val="1"/>
        <c:lblAlgn val="ctr"/>
        <c:lblOffset val="100"/>
        <c:noMultiLvlLbl val="0"/>
      </c:catAx>
      <c:valAx>
        <c:axId val="83383360"/>
        <c:scaling>
          <c:orientation val="minMax"/>
          <c:max val="1.5000000000000003E-2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40512000"/>
        <c:crosses val="autoZero"/>
        <c:crossBetween val="between"/>
        <c:majorUnit val="5.000000000000001E-3"/>
        <c:minorUnit val="5.000000000000001E-3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i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ko-KR" sz="900" i="0" dirty="0" smtClean="0">
                <a:latin typeface="Arial" panose="020B0604020202020204" pitchFamily="34" charset="0"/>
                <a:cs typeface="Arial" panose="020B0604020202020204" pitchFamily="34" charset="0"/>
              </a:rPr>
              <a:t>LOC_Os03g02550</a:t>
            </a:r>
            <a:endParaRPr lang="en-US" altLang="ko-KR" sz="900" i="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962781738058528"/>
          <c:y val="2.4824234694454431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6897395164654664"/>
          <c:y val="0.15877246664879618"/>
          <c:w val="0.6350253149116627"/>
          <c:h val="0.624311128900587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NA seq validation_Down 최종.xlsx]Down_Vil2 만'!$J$53</c:f>
              <c:strCache>
                <c:ptCount val="1"/>
                <c:pt idx="0">
                  <c:v>03g02550</c:v>
                </c:pt>
              </c:strCache>
            </c:strRef>
          </c:tx>
          <c:spPr>
            <a:noFill/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73A-41F0-80A3-106534BA4C98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73A-41F0-80A3-106534BA4C98}"/>
              </c:ext>
            </c:extLst>
          </c:dPt>
          <c:errBars>
            <c:errBarType val="both"/>
            <c:errValType val="cust"/>
            <c:noEndCap val="0"/>
            <c:plus>
              <c:numRef>
                <c:f>'[RNA seq validation_Down 최종.xlsx]Down_Vil2 만'!$K$54:$K$55</c:f>
                <c:numCache>
                  <c:formatCode>General</c:formatCode>
                  <c:ptCount val="2"/>
                  <c:pt idx="0">
                    <c:v>8.3406295838339359E-4</c:v>
                  </c:pt>
                  <c:pt idx="1">
                    <c:v>1.5084247991099045E-3</c:v>
                  </c:pt>
                </c:numCache>
              </c:numRef>
            </c:plus>
            <c:minus>
              <c:numRef>
                <c:f>'[RNA seq validation_Down 최종.xlsx]Down_Vil2 만'!$K$54:$K$55</c:f>
                <c:numCache>
                  <c:formatCode>General</c:formatCode>
                  <c:ptCount val="2"/>
                  <c:pt idx="0">
                    <c:v>8.3406295838339359E-4</c:v>
                  </c:pt>
                  <c:pt idx="1">
                    <c:v>1.5084247991099045E-3</c:v>
                  </c:pt>
                </c:numCache>
              </c:numRef>
            </c:minus>
          </c:errBars>
          <c:cat>
            <c:strRef>
              <c:f>'[RNA seq validation_Down 최종.xlsx]Down_Vil2 만'!$I$54:$I$55</c:f>
              <c:strCache>
                <c:ptCount val="2"/>
                <c:pt idx="0">
                  <c:v>WT</c:v>
                </c:pt>
                <c:pt idx="1">
                  <c:v>OsVIL2 OX</c:v>
                </c:pt>
              </c:strCache>
            </c:strRef>
          </c:cat>
          <c:val>
            <c:numRef>
              <c:f>'[RNA seq validation_Down 최종.xlsx]Down_Vil2 만'!$J$54:$J$55</c:f>
              <c:numCache>
                <c:formatCode>General</c:formatCode>
                <c:ptCount val="2"/>
                <c:pt idx="0">
                  <c:v>2.8366105360264737E-2</c:v>
                </c:pt>
                <c:pt idx="1">
                  <c:v>3.809673802286347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073A-41F0-80A3-106534BA4C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510464"/>
        <c:axId val="36847616"/>
      </c:barChart>
      <c:catAx>
        <c:axId val="405104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700"/>
            </a:pPr>
            <a:endParaRPr lang="ko-KR"/>
          </a:p>
        </c:txPr>
        <c:crossAx val="36847616"/>
        <c:crosses val="autoZero"/>
        <c:auto val="1"/>
        <c:lblAlgn val="ctr"/>
        <c:lblOffset val="100"/>
        <c:noMultiLvlLbl val="0"/>
      </c:catAx>
      <c:valAx>
        <c:axId val="36847616"/>
        <c:scaling>
          <c:orientation val="minMax"/>
          <c:max val="3.0000000000000006E-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40510464"/>
        <c:crosses val="autoZero"/>
        <c:crossBetween val="between"/>
        <c:majorUnit val="1.0000000000000002E-2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i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ko-KR" sz="900" i="0" dirty="0" smtClean="0">
                <a:latin typeface="Arial" panose="020B0604020202020204" pitchFamily="34" charset="0"/>
                <a:cs typeface="Arial" panose="020B0604020202020204" pitchFamily="34" charset="0"/>
              </a:rPr>
              <a:t>LOC_Os06g19444</a:t>
            </a:r>
            <a:endParaRPr lang="en-US" altLang="ko-KR" sz="900" i="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633720362962241"/>
          <c:y val="4.728928041597112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6083196294871108"/>
          <c:y val="0.18391389669558297"/>
          <c:w val="0.62521185599831586"/>
          <c:h val="0.689106237347821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NA seq validation_Down 최종.xlsx]Down_Vil2 만'!$J$59</c:f>
              <c:strCache>
                <c:ptCount val="1"/>
                <c:pt idx="0">
                  <c:v>06g19444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A73-4613-8BFC-1E8B1F01CA8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A73-4613-8BFC-1E8B1F01CA84}"/>
              </c:ext>
            </c:extLst>
          </c:dPt>
          <c:errBars>
            <c:errBarType val="both"/>
            <c:errValType val="cust"/>
            <c:noEndCap val="0"/>
            <c:plus>
              <c:numRef>
                <c:f>'[RNA seq validation_Down 최종.xlsx]Down_Vil2 만'!$K$60:$K$61</c:f>
                <c:numCache>
                  <c:formatCode>General</c:formatCode>
                  <c:ptCount val="2"/>
                  <c:pt idx="0">
                    <c:v>1.1597287020598278E-2</c:v>
                  </c:pt>
                  <c:pt idx="1">
                    <c:v>2.9089508039985355E-4</c:v>
                  </c:pt>
                </c:numCache>
              </c:numRef>
            </c:plus>
            <c:minus>
              <c:numRef>
                <c:f>'[RNA seq validation_Down 최종.xlsx]Down_Vil2 만'!$K$60:$K$61</c:f>
                <c:numCache>
                  <c:formatCode>General</c:formatCode>
                  <c:ptCount val="2"/>
                  <c:pt idx="0">
                    <c:v>1.1597287020598278E-2</c:v>
                  </c:pt>
                  <c:pt idx="1">
                    <c:v>2.9089508039985355E-4</c:v>
                  </c:pt>
                </c:numCache>
              </c:numRef>
            </c:minus>
          </c:errBars>
          <c:cat>
            <c:strRef>
              <c:f>'[RNA seq validation_Down 최종.xlsx]Down_Vil2 만'!$I$60:$I$61</c:f>
              <c:strCache>
                <c:ptCount val="2"/>
                <c:pt idx="0">
                  <c:v>WT</c:v>
                </c:pt>
                <c:pt idx="1">
                  <c:v>VIL2 OX</c:v>
                </c:pt>
              </c:strCache>
            </c:strRef>
          </c:cat>
          <c:val>
            <c:numRef>
              <c:f>'[RNA seq validation_Down 최종.xlsx]Down_Vil2 만'!$J$60:$J$61</c:f>
              <c:numCache>
                <c:formatCode>General</c:formatCode>
                <c:ptCount val="2"/>
                <c:pt idx="0">
                  <c:v>2.4376534730653279E-2</c:v>
                </c:pt>
                <c:pt idx="1">
                  <c:v>2.053462725225471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AA73-4613-8BFC-1E8B1F01CA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513024"/>
        <c:axId val="36849344"/>
      </c:barChart>
      <c:catAx>
        <c:axId val="405130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6849344"/>
        <c:crosses val="autoZero"/>
        <c:auto val="1"/>
        <c:lblAlgn val="ctr"/>
        <c:lblOffset val="100"/>
        <c:noMultiLvlLbl val="0"/>
      </c:catAx>
      <c:valAx>
        <c:axId val="3684934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40513024"/>
        <c:crosses val="autoZero"/>
        <c:crossBetween val="between"/>
        <c:majorUnit val="1.0000000000000002E-2"/>
      </c:valAx>
    </c:plotArea>
    <c:plotVisOnly val="1"/>
    <c:dispBlanksAs val="gap"/>
    <c:showDLblsOverMax val="0"/>
  </c:chart>
  <c:txPr>
    <a:bodyPr/>
    <a:lstStyle/>
    <a:p>
      <a:pPr>
        <a:defRPr baseline="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i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900" i="0" dirty="0" smtClean="0">
                <a:latin typeface="Arial" panose="020B0604020202020204" pitchFamily="34" charset="0"/>
                <a:cs typeface="Arial" panose="020B0604020202020204" pitchFamily="34" charset="0"/>
              </a:rPr>
              <a:t>LOC_Os11g15040</a:t>
            </a:r>
            <a:endParaRPr lang="en-US" altLang="ko-KR" sz="900" i="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3713167340707175"/>
          <c:y val="2.9217078006095977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873197933594305"/>
          <c:y val="0.11823322262446609"/>
          <c:w val="0.57558836427422899"/>
          <c:h val="0.625426010450667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NA seq validation_Down 최종.xlsx]Down_Vil2 만'!$J$73</c:f>
              <c:strCache>
                <c:ptCount val="1"/>
                <c:pt idx="0">
                  <c:v>11g15040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076-4859-88AE-20C34A06C3C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076-4859-88AE-20C34A06C3C9}"/>
              </c:ext>
            </c:extLst>
          </c:dPt>
          <c:errBars>
            <c:errBarType val="both"/>
            <c:errValType val="cust"/>
            <c:noEndCap val="0"/>
            <c:plus>
              <c:numRef>
                <c:f>'[RNA seq validation_Down 최종.xlsx]Down_Vil2 만'!$K$74:$K$75</c:f>
                <c:numCache>
                  <c:formatCode>General</c:formatCode>
                  <c:ptCount val="2"/>
                  <c:pt idx="0">
                    <c:v>1.2702707459934703E-4</c:v>
                  </c:pt>
                  <c:pt idx="1">
                    <c:v>3.8562551769078027E-5</c:v>
                  </c:pt>
                </c:numCache>
              </c:numRef>
            </c:plus>
            <c:minus>
              <c:numRef>
                <c:f>'[RNA seq validation_Down 최종.xlsx]Down_Vil2 만'!$K$74:$K$75</c:f>
                <c:numCache>
                  <c:formatCode>General</c:formatCode>
                  <c:ptCount val="2"/>
                  <c:pt idx="0">
                    <c:v>1.2702707459934703E-4</c:v>
                  </c:pt>
                  <c:pt idx="1">
                    <c:v>3.8562551769078027E-5</c:v>
                  </c:pt>
                </c:numCache>
              </c:numRef>
            </c:minus>
          </c:errBars>
          <c:cat>
            <c:strRef>
              <c:f>'[RNA seq validation_Down 최종.xlsx]Down_Vil2 만'!$I$74:$I$75</c:f>
              <c:strCache>
                <c:ptCount val="2"/>
                <c:pt idx="0">
                  <c:v>WT</c:v>
                </c:pt>
                <c:pt idx="1">
                  <c:v>VIL2 OX</c:v>
                </c:pt>
              </c:strCache>
            </c:strRef>
          </c:cat>
          <c:val>
            <c:numRef>
              <c:f>'[RNA seq validation_Down 최종.xlsx]Down_Vil2 만'!$J$74:$J$75</c:f>
              <c:numCache>
                <c:formatCode>General</c:formatCode>
                <c:ptCount val="2"/>
                <c:pt idx="0">
                  <c:v>6.4796815383261503E-3</c:v>
                </c:pt>
                <c:pt idx="1">
                  <c:v>1.1006839895096718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1076-4859-88AE-20C34A06C3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521344"/>
        <c:axId val="36851072"/>
      </c:barChart>
      <c:catAx>
        <c:axId val="625213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ko-KR"/>
          </a:p>
        </c:txPr>
        <c:crossAx val="36851072"/>
        <c:crosses val="autoZero"/>
        <c:auto val="1"/>
        <c:lblAlgn val="ctr"/>
        <c:lblOffset val="100"/>
        <c:noMultiLvlLbl val="0"/>
      </c:catAx>
      <c:valAx>
        <c:axId val="36851072"/>
        <c:scaling>
          <c:orientation val="minMax"/>
          <c:max val="8.0000000000000019E-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62521344"/>
        <c:crosses val="autoZero"/>
        <c:crossBetween val="between"/>
        <c:majorUnit val="2.0000000000000005E-3"/>
      </c:valAx>
    </c:plotArea>
    <c:plotVisOnly val="1"/>
    <c:dispBlanksAs val="gap"/>
    <c:showDLblsOverMax val="0"/>
  </c:chart>
  <c:txPr>
    <a:bodyPr/>
    <a:lstStyle/>
    <a:p>
      <a:pPr>
        <a:defRPr baseline="0">
          <a:latin typeface="Arial" panose="020B0604020202020204" pitchFamily="34" charset="0"/>
          <a:ea typeface="Arial Unicode MS" panose="020B0604020202020204" pitchFamily="50" charset="-127"/>
        </a:defRPr>
      </a:pPr>
      <a:endParaRPr lang="ko-K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i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ko-KR" sz="900" i="0" dirty="0" smtClean="0">
                <a:latin typeface="Arial" panose="020B0604020202020204" pitchFamily="34" charset="0"/>
                <a:cs typeface="Arial" panose="020B0604020202020204" pitchFamily="34" charset="0"/>
              </a:rPr>
              <a:t>LOC_Os02g58160</a:t>
            </a:r>
            <a:endParaRPr lang="en-US" altLang="ko-KR" sz="900" i="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4439288476411447"/>
          <c:y val="5.67965599924984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7638049596958425"/>
          <c:y val="0.20358384678361638"/>
          <c:w val="0.62094390359452045"/>
          <c:h val="0.67520874216014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NA seq validation_Down 최종.xlsx]Down_Vil2 만'!$J$68</c:f>
              <c:strCache>
                <c:ptCount val="1"/>
                <c:pt idx="0">
                  <c:v>02g58160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6FC-4F29-84BD-054DFBE23F3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6FC-4F29-84BD-054DFBE23F30}"/>
              </c:ext>
            </c:extLst>
          </c:dPt>
          <c:errBars>
            <c:errBarType val="both"/>
            <c:errValType val="cust"/>
            <c:noEndCap val="0"/>
            <c:plus>
              <c:numRef>
                <c:f>'[RNA seq validation_Down 최종.xlsx]Down_Vil2 만'!$K$69:$K$70</c:f>
                <c:numCache>
                  <c:formatCode>General</c:formatCode>
                  <c:ptCount val="2"/>
                  <c:pt idx="0">
                    <c:v>5.9504994492268865E-4</c:v>
                  </c:pt>
                  <c:pt idx="1">
                    <c:v>1.3143656146201134E-4</c:v>
                  </c:pt>
                </c:numCache>
              </c:numRef>
            </c:plus>
            <c:minus>
              <c:numRef>
                <c:f>'[RNA seq validation_Down 최종.xlsx]Down_Vil2 만'!$K$69:$K$70</c:f>
                <c:numCache>
                  <c:formatCode>General</c:formatCode>
                  <c:ptCount val="2"/>
                  <c:pt idx="0">
                    <c:v>5.9504994492268865E-4</c:v>
                  </c:pt>
                  <c:pt idx="1">
                    <c:v>1.3143656146201134E-4</c:v>
                  </c:pt>
                </c:numCache>
              </c:numRef>
            </c:minus>
          </c:errBars>
          <c:cat>
            <c:strRef>
              <c:f>'[RNA seq validation_Down 최종.xlsx]Down_Vil2 만'!$I$69:$I$70</c:f>
              <c:strCache>
                <c:ptCount val="2"/>
                <c:pt idx="0">
                  <c:v>WT</c:v>
                </c:pt>
                <c:pt idx="1">
                  <c:v>VIL2 OX</c:v>
                </c:pt>
              </c:strCache>
            </c:strRef>
          </c:cat>
          <c:val>
            <c:numRef>
              <c:f>'[RNA seq validation_Down 최종.xlsx]Down_Vil2 만'!$J$69:$J$70</c:f>
              <c:numCache>
                <c:formatCode>General</c:formatCode>
                <c:ptCount val="2"/>
                <c:pt idx="0">
                  <c:v>8.6787172930853033E-3</c:v>
                </c:pt>
                <c:pt idx="1">
                  <c:v>3.8529288327548647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66FC-4F29-84BD-054DFBE23F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521856"/>
        <c:axId val="36852800"/>
      </c:barChart>
      <c:catAx>
        <c:axId val="625218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6852800"/>
        <c:crosses val="autoZero"/>
        <c:auto val="1"/>
        <c:lblAlgn val="ctr"/>
        <c:lblOffset val="100"/>
        <c:noMultiLvlLbl val="0"/>
      </c:catAx>
      <c:valAx>
        <c:axId val="36852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62521856"/>
        <c:crosses val="autoZero"/>
        <c:crossBetween val="between"/>
        <c:majorUnit val="2.0000000000000005E-3"/>
      </c:valAx>
    </c:plotArea>
    <c:plotVisOnly val="1"/>
    <c:dispBlanksAs val="gap"/>
    <c:showDLblsOverMax val="0"/>
  </c:chart>
  <c:txPr>
    <a:bodyPr/>
    <a:lstStyle/>
    <a:p>
      <a:pPr>
        <a:defRPr baseline="0">
          <a:latin typeface="Arial" panose="020B0604020202020204" pitchFamily="34" charset="0"/>
          <a:ea typeface="Arial Unicode MS" panose="020B0604020202020204" pitchFamily="50" charset="-127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i="0">
                <a:latin typeface="Arial" panose="020B0604020202020204" pitchFamily="34" charset="0"/>
                <a:ea typeface="휴먼편지체" panose="02030504000101010101" pitchFamily="18" charset="-127"/>
                <a:cs typeface="Arial" panose="020B0604020202020204" pitchFamily="34" charset="0"/>
              </a:defRPr>
            </a:pPr>
            <a:r>
              <a:rPr lang="en-US" altLang="ko-KR" sz="900" i="0" dirty="0" smtClean="0">
                <a:latin typeface="Arial" panose="020B0604020202020204" pitchFamily="34" charset="0"/>
                <a:ea typeface="휴먼편지체" panose="02030504000101010101" pitchFamily="18" charset="-127"/>
                <a:cs typeface="Arial" panose="020B0604020202020204" pitchFamily="34" charset="0"/>
              </a:rPr>
              <a:t>LOC_Os01g15900</a:t>
            </a:r>
            <a:endParaRPr lang="en-US" altLang="ko-KR" sz="900" i="0" dirty="0">
              <a:latin typeface="Arial" panose="020B0604020202020204" pitchFamily="34" charset="0"/>
              <a:ea typeface="휴먼편지체" panose="02030504000101010101" pitchFamily="18" charset="-127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511034514547941"/>
          <c:y val="6.047601539381652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6430038749758822"/>
          <c:y val="0.21806234967606719"/>
          <c:w val="0.62650418846132827"/>
          <c:h val="0.672836427853509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NA seq validation_Down 최종.xlsx]Down_Vil2 만'!$J$64</c:f>
              <c:strCache>
                <c:ptCount val="1"/>
                <c:pt idx="0">
                  <c:v>01g15900</c:v>
                </c:pt>
              </c:strCache>
            </c:strRef>
          </c:tx>
          <c:spPr>
            <a:noFill/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177-4FB0-B67A-0514670EC94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177-4FB0-B67A-0514670EC949}"/>
              </c:ext>
            </c:extLst>
          </c:dPt>
          <c:errBars>
            <c:errBarType val="both"/>
            <c:errValType val="cust"/>
            <c:noEndCap val="0"/>
            <c:plus>
              <c:numRef>
                <c:f>'[RNA seq validation_Down 최종.xlsx]Down_Vil2 만'!$K$65:$K$66</c:f>
                <c:numCache>
                  <c:formatCode>General</c:formatCode>
                  <c:ptCount val="2"/>
                  <c:pt idx="0">
                    <c:v>6.0320596008655546E-3</c:v>
                  </c:pt>
                  <c:pt idx="1">
                    <c:v>2.3422623524347436E-3</c:v>
                  </c:pt>
                </c:numCache>
              </c:numRef>
            </c:plus>
            <c:minus>
              <c:numRef>
                <c:f>'[RNA seq validation_Down 최종.xlsx]Down_Vil2 만'!$K$65:$K$66</c:f>
                <c:numCache>
                  <c:formatCode>General</c:formatCode>
                  <c:ptCount val="2"/>
                  <c:pt idx="0">
                    <c:v>6.0320596008655546E-3</c:v>
                  </c:pt>
                  <c:pt idx="1">
                    <c:v>2.3422623524347436E-3</c:v>
                  </c:pt>
                </c:numCache>
              </c:numRef>
            </c:minus>
          </c:errBars>
          <c:cat>
            <c:strRef>
              <c:f>'[RNA seq validation_Down 최종.xlsx]Down_Vil2 만'!$I$65:$I$66</c:f>
              <c:strCache>
                <c:ptCount val="2"/>
                <c:pt idx="0">
                  <c:v>WT</c:v>
                </c:pt>
                <c:pt idx="1">
                  <c:v>VIL2 OX</c:v>
                </c:pt>
              </c:strCache>
            </c:strRef>
          </c:cat>
          <c:val>
            <c:numRef>
              <c:f>'[RNA seq validation_Down 최종.xlsx]Down_Vil2 만'!$J$65:$J$66</c:f>
              <c:numCache>
                <c:formatCode>General</c:formatCode>
                <c:ptCount val="2"/>
                <c:pt idx="0">
                  <c:v>4.1171330917966278E-2</c:v>
                </c:pt>
                <c:pt idx="1">
                  <c:v>1.674375453244013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6177-4FB0-B67A-0514670EC9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522880"/>
        <c:axId val="36854528"/>
      </c:barChart>
      <c:catAx>
        <c:axId val="62522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6854528"/>
        <c:crosses val="autoZero"/>
        <c:auto val="1"/>
        <c:lblAlgn val="ctr"/>
        <c:lblOffset val="100"/>
        <c:noMultiLvlLbl val="0"/>
      </c:catAx>
      <c:valAx>
        <c:axId val="36854528"/>
        <c:scaling>
          <c:orientation val="minMax"/>
          <c:max val="5.000000000000001E-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62522880"/>
        <c:crosses val="autoZero"/>
        <c:crossBetween val="between"/>
        <c:majorUnit val="1.0000000000000002E-2"/>
      </c:valAx>
    </c:plotArea>
    <c:plotVisOnly val="1"/>
    <c:dispBlanksAs val="gap"/>
    <c:showDLblsOverMax val="0"/>
  </c:chart>
  <c:txPr>
    <a:bodyPr/>
    <a:lstStyle/>
    <a:p>
      <a:pPr>
        <a:defRPr baseline="0">
          <a:latin typeface="Arial" panose="020B0604020202020204" pitchFamily="34" charset="0"/>
          <a:ea typeface="Arial Unicode MS" panose="020B0604020202020204" pitchFamily="50" charset="-127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D82-4293-8669-5923822E1F23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F$3:$F$4</c:f>
                <c:numCache>
                  <c:formatCode>General</c:formatCode>
                  <c:ptCount val="2"/>
                  <c:pt idx="0">
                    <c:v>3.3999999999999998E-3</c:v>
                  </c:pt>
                  <c:pt idx="1">
                    <c:v>2.3999999999999998E-3</c:v>
                  </c:pt>
                </c:numCache>
              </c:numRef>
            </c:plus>
            <c:minus>
              <c:numRef>
                <c:f>Sheet1!$F$3:$F$4</c:f>
                <c:numCache>
                  <c:formatCode>General</c:formatCode>
                  <c:ptCount val="2"/>
                  <c:pt idx="0">
                    <c:v>3.3999999999999998E-3</c:v>
                  </c:pt>
                  <c:pt idx="1">
                    <c:v>2.39999999999999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3:$E$4</c:f>
              <c:numCache>
                <c:formatCode>General</c:formatCode>
                <c:ptCount val="2"/>
                <c:pt idx="0">
                  <c:v>5.1999999999999998E-2</c:v>
                </c:pt>
                <c:pt idx="1">
                  <c:v>4.599999999999999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D82-4293-8669-5923822E1F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757440"/>
        <c:axId val="40452672"/>
      </c:barChart>
      <c:catAx>
        <c:axId val="85757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0452672"/>
        <c:crosses val="autoZero"/>
        <c:auto val="1"/>
        <c:lblAlgn val="ctr"/>
        <c:lblOffset val="100"/>
        <c:noMultiLvlLbl val="0"/>
      </c:catAx>
      <c:valAx>
        <c:axId val="4045267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5757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F1D-47B4-B73A-2AAF9377BA87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J$3:$J$4</c:f>
                <c:numCache>
                  <c:formatCode>General</c:formatCode>
                  <c:ptCount val="2"/>
                  <c:pt idx="0">
                    <c:v>6.8000000000000005E-2</c:v>
                  </c:pt>
                  <c:pt idx="1">
                    <c:v>3.4000000000000002E-2</c:v>
                  </c:pt>
                </c:numCache>
              </c:numRef>
            </c:plus>
            <c:minus>
              <c:numRef>
                <c:f>Sheet1!$J$3:$J$4</c:f>
                <c:numCache>
                  <c:formatCode>General</c:formatCode>
                  <c:ptCount val="2"/>
                  <c:pt idx="0">
                    <c:v>6.8000000000000005E-2</c:v>
                  </c:pt>
                  <c:pt idx="1">
                    <c:v>3.40000000000000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I$3:$I$4</c:f>
              <c:numCache>
                <c:formatCode>General</c:formatCode>
                <c:ptCount val="2"/>
                <c:pt idx="0">
                  <c:v>0.57299999999999995</c:v>
                </c:pt>
                <c:pt idx="1">
                  <c:v>0.4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F1D-47B4-B73A-2AAF9377BA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778432"/>
        <c:axId val="40454400"/>
      </c:barChart>
      <c:catAx>
        <c:axId val="85778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0454400"/>
        <c:crosses val="autoZero"/>
        <c:auto val="1"/>
        <c:lblAlgn val="ctr"/>
        <c:lblOffset val="100"/>
        <c:noMultiLvlLbl val="0"/>
      </c:catAx>
      <c:valAx>
        <c:axId val="40454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57784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814-4879-8838-C90638E3690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N$3:$N$4</c:f>
                <c:numCache>
                  <c:formatCode>General</c:formatCode>
                  <c:ptCount val="2"/>
                  <c:pt idx="0">
                    <c:v>3.0799999999999998E-3</c:v>
                  </c:pt>
                  <c:pt idx="1">
                    <c:v>2.5600000000000002E-3</c:v>
                  </c:pt>
                </c:numCache>
              </c:numRef>
            </c:plus>
            <c:minus>
              <c:numRef>
                <c:f>Sheet1!$N$3:$N$4</c:f>
                <c:numCache>
                  <c:formatCode>General</c:formatCode>
                  <c:ptCount val="2"/>
                  <c:pt idx="0">
                    <c:v>3.0799999999999998E-3</c:v>
                  </c:pt>
                  <c:pt idx="1">
                    <c:v>2.560000000000000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M$3:$M$4</c:f>
              <c:numCache>
                <c:formatCode>General</c:formatCode>
                <c:ptCount val="2"/>
                <c:pt idx="0">
                  <c:v>3.1E-2</c:v>
                </c:pt>
                <c:pt idx="1">
                  <c:v>3.4000000000000002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814-4879-8838-C90638E369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778944"/>
        <c:axId val="40458432"/>
      </c:barChart>
      <c:catAx>
        <c:axId val="85778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0458432"/>
        <c:crosses val="autoZero"/>
        <c:auto val="1"/>
        <c:lblAlgn val="ctr"/>
        <c:lblOffset val="100"/>
        <c:noMultiLvlLbl val="0"/>
      </c:catAx>
      <c:valAx>
        <c:axId val="4045843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5778944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420CF5-109E-4605-9232-27F0EC347CA6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0DC6E8-F2D3-47BC-9F6E-0B653624ECE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5801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856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376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540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3982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3061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1816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240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2978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8738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5672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8235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E43C6-069E-478A-A492-83CD5543D125}" type="datetimeFigureOut">
              <a:rPr lang="ko-KR" altLang="en-US" smtClean="0"/>
              <a:pPr/>
              <a:t>2018-05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4D567-576A-4978-91CE-9E73749B072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1034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1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1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2262601"/>
              </p:ext>
            </p:extLst>
          </p:nvPr>
        </p:nvGraphicFramePr>
        <p:xfrm>
          <a:off x="1255190" y="3449132"/>
          <a:ext cx="1401945" cy="1779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2512879"/>
              </p:ext>
            </p:extLst>
          </p:nvPr>
        </p:nvGraphicFramePr>
        <p:xfrm>
          <a:off x="3171874" y="1371601"/>
          <a:ext cx="1469555" cy="2000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0168728"/>
              </p:ext>
            </p:extLst>
          </p:nvPr>
        </p:nvGraphicFramePr>
        <p:xfrm>
          <a:off x="5090792" y="1313439"/>
          <a:ext cx="1498919" cy="1851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차트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3428563"/>
              </p:ext>
            </p:extLst>
          </p:nvPr>
        </p:nvGraphicFramePr>
        <p:xfrm>
          <a:off x="5080197" y="3505200"/>
          <a:ext cx="1539225" cy="20272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차트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8002675"/>
              </p:ext>
            </p:extLst>
          </p:nvPr>
        </p:nvGraphicFramePr>
        <p:xfrm>
          <a:off x="3164741" y="3389938"/>
          <a:ext cx="1387389" cy="1866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40" name="그룹 39"/>
          <p:cNvGrpSpPr/>
          <p:nvPr/>
        </p:nvGrpSpPr>
        <p:grpSpPr>
          <a:xfrm>
            <a:off x="1266393" y="1286112"/>
            <a:ext cx="1728314" cy="2017494"/>
            <a:chOff x="1060482" y="1267062"/>
            <a:chExt cx="1559912" cy="2017494"/>
          </a:xfrm>
        </p:grpSpPr>
        <p:graphicFrame>
          <p:nvGraphicFramePr>
            <p:cNvPr id="7" name="차트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51161678"/>
                </p:ext>
              </p:extLst>
            </p:nvPr>
          </p:nvGraphicFramePr>
          <p:xfrm>
            <a:off x="1060482" y="1267062"/>
            <a:ext cx="1366757" cy="18576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10" name="그룹 9"/>
            <p:cNvGrpSpPr/>
            <p:nvPr/>
          </p:nvGrpSpPr>
          <p:grpSpPr>
            <a:xfrm>
              <a:off x="1443800" y="2915224"/>
              <a:ext cx="1176594" cy="369332"/>
              <a:chOff x="2077639" y="6422595"/>
              <a:chExt cx="1394520" cy="369332"/>
            </a:xfrm>
          </p:grpSpPr>
          <p:sp>
            <p:nvSpPr>
              <p:cNvPr id="11" name="직사각형 10"/>
              <p:cNvSpPr/>
              <p:nvPr/>
            </p:nvSpPr>
            <p:spPr>
              <a:xfrm>
                <a:off x="2077639" y="6451171"/>
                <a:ext cx="1394520" cy="2308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" name="그룹 11"/>
              <p:cNvGrpSpPr/>
              <p:nvPr/>
            </p:nvGrpSpPr>
            <p:grpSpPr>
              <a:xfrm>
                <a:off x="2109306" y="6422595"/>
                <a:ext cx="1172022" cy="369332"/>
                <a:chOff x="753505" y="3126785"/>
                <a:chExt cx="1172022" cy="369332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753505" y="3126785"/>
                  <a:ext cx="38911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020654" y="3126785"/>
                  <a:ext cx="90487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sVIL2</a:t>
                  </a:r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X #1</a:t>
                  </a:r>
                </a:p>
              </p:txBody>
            </p:sp>
          </p:grpSp>
        </p:grpSp>
      </p:grpSp>
      <p:grpSp>
        <p:nvGrpSpPr>
          <p:cNvPr id="15" name="그룹 14"/>
          <p:cNvGrpSpPr/>
          <p:nvPr/>
        </p:nvGrpSpPr>
        <p:grpSpPr>
          <a:xfrm>
            <a:off x="3622663" y="2953324"/>
            <a:ext cx="1303616" cy="369332"/>
            <a:chOff x="2077639" y="6422595"/>
            <a:chExt cx="1394520" cy="369332"/>
          </a:xfrm>
        </p:grpSpPr>
        <p:sp>
          <p:nvSpPr>
            <p:cNvPr id="16" name="직사각형 15"/>
            <p:cNvSpPr/>
            <p:nvPr/>
          </p:nvSpPr>
          <p:spPr>
            <a:xfrm>
              <a:off x="2077639" y="6451171"/>
              <a:ext cx="1394520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그룹 16"/>
            <p:cNvGrpSpPr/>
            <p:nvPr/>
          </p:nvGrpSpPr>
          <p:grpSpPr>
            <a:xfrm>
              <a:off x="2088928" y="6422595"/>
              <a:ext cx="1127867" cy="369332"/>
              <a:chOff x="733127" y="3126785"/>
              <a:chExt cx="1127867" cy="369332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733127" y="3126785"/>
                <a:ext cx="3891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956122" y="3126785"/>
                <a:ext cx="9048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OX #1</a:t>
                </a:r>
              </a:p>
            </p:txBody>
          </p:sp>
        </p:grpSp>
      </p:grpSp>
      <p:grpSp>
        <p:nvGrpSpPr>
          <p:cNvPr id="20" name="그룹 19"/>
          <p:cNvGrpSpPr/>
          <p:nvPr/>
        </p:nvGrpSpPr>
        <p:grpSpPr>
          <a:xfrm>
            <a:off x="5534337" y="2915224"/>
            <a:ext cx="1303616" cy="369332"/>
            <a:chOff x="2077639" y="6422595"/>
            <a:chExt cx="1394520" cy="369332"/>
          </a:xfrm>
        </p:grpSpPr>
        <p:sp>
          <p:nvSpPr>
            <p:cNvPr id="21" name="직사각형 20"/>
            <p:cNvSpPr/>
            <p:nvPr/>
          </p:nvSpPr>
          <p:spPr>
            <a:xfrm>
              <a:off x="2077639" y="6451171"/>
              <a:ext cx="1394520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그룹 21"/>
            <p:cNvGrpSpPr/>
            <p:nvPr/>
          </p:nvGrpSpPr>
          <p:grpSpPr>
            <a:xfrm>
              <a:off x="2088928" y="6422595"/>
              <a:ext cx="1138057" cy="369332"/>
              <a:chOff x="733127" y="3126785"/>
              <a:chExt cx="1138057" cy="369332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733127" y="3126785"/>
                <a:ext cx="3891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966311" y="3126785"/>
                <a:ext cx="9048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 #1</a:t>
                </a:r>
              </a:p>
            </p:txBody>
          </p:sp>
        </p:grpSp>
      </p:grpSp>
      <p:grpSp>
        <p:nvGrpSpPr>
          <p:cNvPr id="25" name="그룹 24"/>
          <p:cNvGrpSpPr/>
          <p:nvPr/>
        </p:nvGrpSpPr>
        <p:grpSpPr>
          <a:xfrm>
            <a:off x="1700639" y="5020249"/>
            <a:ext cx="1176594" cy="369332"/>
            <a:chOff x="2077639" y="6422595"/>
            <a:chExt cx="1394520" cy="369332"/>
          </a:xfrm>
        </p:grpSpPr>
        <p:sp>
          <p:nvSpPr>
            <p:cNvPr id="26" name="직사각형 25"/>
            <p:cNvSpPr/>
            <p:nvPr/>
          </p:nvSpPr>
          <p:spPr>
            <a:xfrm>
              <a:off x="2077639" y="6451171"/>
              <a:ext cx="1394520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" name="그룹 26"/>
            <p:cNvGrpSpPr/>
            <p:nvPr/>
          </p:nvGrpSpPr>
          <p:grpSpPr>
            <a:xfrm>
              <a:off x="2088928" y="6422595"/>
              <a:ext cx="1265874" cy="369332"/>
              <a:chOff x="733127" y="3126785"/>
              <a:chExt cx="1265874" cy="369332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733127" y="3126785"/>
                <a:ext cx="3891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1044697" y="3126785"/>
                <a:ext cx="954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OX #1</a:t>
                </a:r>
              </a:p>
            </p:txBody>
          </p:sp>
        </p:grpSp>
      </p:grpSp>
      <p:grpSp>
        <p:nvGrpSpPr>
          <p:cNvPr id="30" name="그룹 29"/>
          <p:cNvGrpSpPr/>
          <p:nvPr/>
        </p:nvGrpSpPr>
        <p:grpSpPr>
          <a:xfrm>
            <a:off x="3621192" y="5020249"/>
            <a:ext cx="1176594" cy="369332"/>
            <a:chOff x="2077639" y="6422595"/>
            <a:chExt cx="1394520" cy="369332"/>
          </a:xfrm>
        </p:grpSpPr>
        <p:sp>
          <p:nvSpPr>
            <p:cNvPr id="31" name="직사각형 30"/>
            <p:cNvSpPr/>
            <p:nvPr/>
          </p:nvSpPr>
          <p:spPr>
            <a:xfrm>
              <a:off x="2077639" y="6451171"/>
              <a:ext cx="1394520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그룹 31"/>
            <p:cNvGrpSpPr/>
            <p:nvPr/>
          </p:nvGrpSpPr>
          <p:grpSpPr>
            <a:xfrm>
              <a:off x="2088928" y="6422595"/>
              <a:ext cx="1270871" cy="369332"/>
              <a:chOff x="733127" y="3126785"/>
              <a:chExt cx="1270871" cy="369332"/>
            </a:xfrm>
          </p:grpSpPr>
          <p:sp>
            <p:nvSpPr>
              <p:cNvPr id="33" name="TextBox 32"/>
              <p:cNvSpPr txBox="1"/>
              <p:nvPr/>
            </p:nvSpPr>
            <p:spPr>
              <a:xfrm>
                <a:off x="733127" y="3126785"/>
                <a:ext cx="3891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063512" y="3126785"/>
                <a:ext cx="9404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OX #1</a:t>
                </a:r>
              </a:p>
            </p:txBody>
          </p:sp>
        </p:grpSp>
      </p:grpSp>
      <p:grpSp>
        <p:nvGrpSpPr>
          <p:cNvPr id="35" name="그룹 34"/>
          <p:cNvGrpSpPr/>
          <p:nvPr/>
        </p:nvGrpSpPr>
        <p:grpSpPr>
          <a:xfrm>
            <a:off x="5528103" y="5020249"/>
            <a:ext cx="1176594" cy="407414"/>
            <a:chOff x="2077639" y="6422595"/>
            <a:chExt cx="1394520" cy="407414"/>
          </a:xfrm>
        </p:grpSpPr>
        <p:sp>
          <p:nvSpPr>
            <p:cNvPr id="36" name="직사각형 35"/>
            <p:cNvSpPr/>
            <p:nvPr/>
          </p:nvSpPr>
          <p:spPr>
            <a:xfrm>
              <a:off x="2077639" y="6451171"/>
              <a:ext cx="1394520" cy="3788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7" name="그룹 36"/>
            <p:cNvGrpSpPr/>
            <p:nvPr/>
          </p:nvGrpSpPr>
          <p:grpSpPr>
            <a:xfrm>
              <a:off x="2088928" y="6422595"/>
              <a:ext cx="1269526" cy="369332"/>
              <a:chOff x="733127" y="3126785"/>
              <a:chExt cx="1269526" cy="369332"/>
            </a:xfrm>
          </p:grpSpPr>
          <p:sp>
            <p:nvSpPr>
              <p:cNvPr id="38" name="TextBox 37"/>
              <p:cNvSpPr txBox="1"/>
              <p:nvPr/>
            </p:nvSpPr>
            <p:spPr>
              <a:xfrm>
                <a:off x="733127" y="3126785"/>
                <a:ext cx="3891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074803" y="3126785"/>
                <a:ext cx="92785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OX #1</a:t>
                </a:r>
              </a:p>
            </p:txBody>
          </p:sp>
        </p:grpSp>
      </p:grpSp>
      <p:sp>
        <p:nvSpPr>
          <p:cNvPr id="41" name="TextBox 40"/>
          <p:cNvSpPr txBox="1"/>
          <p:nvPr/>
        </p:nvSpPr>
        <p:spPr>
          <a:xfrm>
            <a:off x="870560" y="1218571"/>
            <a:ext cx="518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765407" y="1218571"/>
            <a:ext cx="655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870560" y="3319057"/>
            <a:ext cx="518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765407" y="3319057"/>
            <a:ext cx="655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e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677399" y="1218571"/>
            <a:ext cx="655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c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677399" y="3319057"/>
            <a:ext cx="655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f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857483" y="5536500"/>
            <a:ext cx="59328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nfirmation of RNA-sequencing by quantitative real-time PCR. Relative expression of LOC_01g15900 (a), LOC_03g02550 (b), LOC_06g19444 (c), LOC_12g03040 (d), LOC_02g58160 (e), and LOC_11g15040 (f) in first internodes of WT and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OsVIL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OX #1 plants. Y-axis, relative transcript level of each gene compared with that of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Error bars indicate standard deviations;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= 3 or more.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307138" y="2106684"/>
            <a:ext cx="1554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ranscript level</a:t>
            </a:r>
          </a:p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OC_Os01g15900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2201986" y="2106684"/>
            <a:ext cx="1554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ranscript level</a:t>
            </a:r>
          </a:p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OC_Os03g02550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4111754" y="2106684"/>
            <a:ext cx="1554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ranscript level</a:t>
            </a:r>
          </a:p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OC_Os06g19444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307138" y="4173609"/>
            <a:ext cx="1554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ranscript level</a:t>
            </a:r>
          </a:p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OC_Os12g03040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2201986" y="4173609"/>
            <a:ext cx="1554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ranscript level</a:t>
            </a:r>
          </a:p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OC_Os02g58160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4111754" y="4173609"/>
            <a:ext cx="1554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transcript level</a:t>
            </a:r>
          </a:p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OC_Os11g15040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9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06923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485858" y="1171609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-185028" y="2506407"/>
            <a:ext cx="17586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transcript level</a:t>
            </a:r>
          </a:p>
          <a:p>
            <a:pPr algn="ctr"/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(LP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787344" y="1184309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2122178" y="2506407"/>
            <a:ext cx="17586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transcript level</a:t>
            </a:r>
          </a:p>
          <a:p>
            <a:pPr algn="ctr"/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(DST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04680" y="1171609"/>
            <a:ext cx="413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c)</a:t>
            </a:r>
            <a:endParaRPr lang="ko-KR" alt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4329609" y="2506407"/>
            <a:ext cx="17586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R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transcript level</a:t>
            </a:r>
          </a:p>
          <a:p>
            <a:pPr algn="ctr"/>
            <a:r>
              <a:rPr lang="en-US" altLang="ko-KR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(DEP1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638257" y="4268601"/>
            <a:ext cx="677353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Figure S2.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Transcript levels of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L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DST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and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DEP1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in WT and OsVIL2-OX plants. Relative expression of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LP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(a),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DST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(b), and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DEP1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(c) revealed by quantitative real-time PCR in first internodes of WT and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OsVIL2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OX #1 plants. Y-axis, relative transcript level of each gene compared with that of 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Ubi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. Error bars indicate standard deviations;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n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= 3 or more.</a:t>
            </a:r>
            <a:endParaRPr lang="ko-KR" altLang="ko-KR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4" name="차트 33"/>
          <p:cNvGraphicFramePr>
            <a:graphicFrameLocks/>
          </p:cNvGraphicFramePr>
          <p:nvPr>
            <p:extLst/>
          </p:nvPr>
        </p:nvGraphicFramePr>
        <p:xfrm>
          <a:off x="915694" y="1590033"/>
          <a:ext cx="1769401" cy="2379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5" name="차트 44"/>
          <p:cNvGraphicFramePr>
            <a:graphicFrameLocks/>
          </p:cNvGraphicFramePr>
          <p:nvPr>
            <p:extLst/>
          </p:nvPr>
        </p:nvGraphicFramePr>
        <p:xfrm>
          <a:off x="3179700" y="1570983"/>
          <a:ext cx="1711752" cy="2379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6" name="차트 45"/>
          <p:cNvGraphicFramePr>
            <a:graphicFrameLocks/>
          </p:cNvGraphicFramePr>
          <p:nvPr>
            <p:extLst/>
          </p:nvPr>
        </p:nvGraphicFramePr>
        <p:xfrm>
          <a:off x="5427822" y="1580508"/>
          <a:ext cx="1769401" cy="23792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0" name="TextBox 49"/>
          <p:cNvSpPr txBox="1"/>
          <p:nvPr/>
        </p:nvSpPr>
        <p:spPr>
          <a:xfrm>
            <a:off x="1732506" y="1368233"/>
            <a:ext cx="540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LP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880623" y="1380933"/>
            <a:ext cx="540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DST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882387" y="1368233"/>
            <a:ext cx="806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DEP1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1419850" y="3748146"/>
            <a:ext cx="1001690" cy="1714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60" name="그룹 59"/>
          <p:cNvGrpSpPr/>
          <p:nvPr/>
        </p:nvGrpSpPr>
        <p:grpSpPr>
          <a:xfrm>
            <a:off x="1438900" y="3710760"/>
            <a:ext cx="1308369" cy="246221"/>
            <a:chOff x="1077890" y="5050291"/>
            <a:chExt cx="1308369" cy="246221"/>
          </a:xfrm>
        </p:grpSpPr>
        <p:sp>
          <p:nvSpPr>
            <p:cNvPr id="61" name="TextBox 60"/>
            <p:cNvSpPr txBox="1"/>
            <p:nvPr/>
          </p:nvSpPr>
          <p:spPr>
            <a:xfrm>
              <a:off x="1372840" y="5050291"/>
              <a:ext cx="10134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VIL2-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 #1</a:t>
              </a:r>
              <a:endParaRPr lang="ko-KR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077890" y="5050291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3665031" y="3710760"/>
            <a:ext cx="1308369" cy="246221"/>
            <a:chOff x="3563429" y="4639672"/>
            <a:chExt cx="1308369" cy="246221"/>
          </a:xfrm>
        </p:grpSpPr>
        <p:sp>
          <p:nvSpPr>
            <p:cNvPr id="63" name="직사각형 62"/>
            <p:cNvSpPr/>
            <p:nvPr/>
          </p:nvSpPr>
          <p:spPr>
            <a:xfrm>
              <a:off x="3563429" y="4677058"/>
              <a:ext cx="1001690" cy="171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64" name="그룹 63"/>
            <p:cNvGrpSpPr/>
            <p:nvPr/>
          </p:nvGrpSpPr>
          <p:grpSpPr>
            <a:xfrm>
              <a:off x="3582479" y="4639672"/>
              <a:ext cx="1289319" cy="246221"/>
              <a:chOff x="1077890" y="5050291"/>
              <a:chExt cx="1289319" cy="246221"/>
            </a:xfrm>
          </p:grpSpPr>
          <p:sp>
            <p:nvSpPr>
              <p:cNvPr id="65" name="TextBox 64"/>
              <p:cNvSpPr txBox="1"/>
              <p:nvPr/>
            </p:nvSpPr>
            <p:spPr>
              <a:xfrm>
                <a:off x="1353790" y="5050291"/>
                <a:ext cx="10134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-</a:t>
                </a:r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 #1</a:t>
                </a:r>
                <a:endParaRPr lang="ko-KR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077890" y="5050291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7" name="그룹 66"/>
          <p:cNvGrpSpPr/>
          <p:nvPr/>
        </p:nvGrpSpPr>
        <p:grpSpPr>
          <a:xfrm>
            <a:off x="5931978" y="3720285"/>
            <a:ext cx="1327419" cy="246221"/>
            <a:chOff x="3563429" y="4639672"/>
            <a:chExt cx="1327419" cy="246221"/>
          </a:xfrm>
        </p:grpSpPr>
        <p:sp>
          <p:nvSpPr>
            <p:cNvPr id="68" name="직사각형 67"/>
            <p:cNvSpPr/>
            <p:nvPr/>
          </p:nvSpPr>
          <p:spPr>
            <a:xfrm>
              <a:off x="3563429" y="4677058"/>
              <a:ext cx="1001690" cy="171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69" name="그룹 68"/>
            <p:cNvGrpSpPr/>
            <p:nvPr/>
          </p:nvGrpSpPr>
          <p:grpSpPr>
            <a:xfrm>
              <a:off x="3582479" y="4639672"/>
              <a:ext cx="1308369" cy="246221"/>
              <a:chOff x="1077890" y="5050291"/>
              <a:chExt cx="1308369" cy="246221"/>
            </a:xfrm>
          </p:grpSpPr>
          <p:sp>
            <p:nvSpPr>
              <p:cNvPr id="70" name="TextBox 69"/>
              <p:cNvSpPr txBox="1"/>
              <p:nvPr/>
            </p:nvSpPr>
            <p:spPr>
              <a:xfrm>
                <a:off x="1372840" y="5050291"/>
                <a:ext cx="10134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VIL2-</a:t>
                </a:r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 #1</a:t>
                </a:r>
                <a:endParaRPr lang="ko-KR" altLang="en-US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1077890" y="5050291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12525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90</TotalTime>
  <Words>281</Words>
  <Application>Microsoft Office PowerPoint</Application>
  <PresentationFormat>사용자 지정</PresentationFormat>
  <Paragraphs>56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정일</dc:creator>
  <cp:lastModifiedBy>User</cp:lastModifiedBy>
  <cp:revision>552</cp:revision>
  <dcterms:created xsi:type="dcterms:W3CDTF">2014-12-16T14:08:06Z</dcterms:created>
  <dcterms:modified xsi:type="dcterms:W3CDTF">2018-05-17T08:49:39Z</dcterms:modified>
</cp:coreProperties>
</file>